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</p:sldIdLst>
  <p:sldSz cx="9144000" cy="6858000" type="screen4x3"/>
  <p:notesSz cx="6858000" cy="9144000"/>
  <p:defaultTextStyle>
    <a:defPPr>
      <a:defRPr lang="vi-V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09" autoAdjust="0"/>
    <p:restoredTop sz="94660"/>
  </p:normalViewPr>
  <p:slideViewPr>
    <p:cSldViewPr snapToGrid="0" showGuides="1">
      <p:cViewPr varScale="1">
        <p:scale>
          <a:sx n="112" d="100"/>
          <a:sy n="112" d="100"/>
        </p:scale>
        <p:origin x="1422" y="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클릭하여 마스터 부제목 스타일 편집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750A5A-F4A0-4667-BE4B-DC860058EF8E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CCFAF4F-25DB-41D8-BF24-45921BAF7BDA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5E535E-BF59-4F25-863A-11316EF0E704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0957102-B2EF-4F23-9F18-0DA6ECB0278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EA3FDC0-F712-4760-9084-3CA042AF39D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EB9D2BD-4A6F-4824-B187-2AF02786FC8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1AB3A8-4A99-417B-9187-223D70D93153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CB40EF8-2660-4DC5-AB0D-E57906810078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FB2658-7FB1-455F-A28B-6086F4064325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3E191B3-3AD5-45BF-8D11-CAF7195C216E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A55F12-D892-44BF-9057-584DB09B0086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255E60F-7785-40C3-9141-657B9706660F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BB0935-011C-460C-B3E5-D90402EFBA7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2945FC1-53BC-4FB7-ADCF-389E7BE19C73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E8396C-43FC-48F0-B7D5-1419620710B9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F5C207B-A4F2-4460-82D4-A57E3277B5F1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33ADB25-5DB0-4BF5-BEC0-F1AAAB573B97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905BDECF-B52B-45F8-82B3-0A470B551A6D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5884F75-D622-4318-99F4-10470380423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4AF779-CEF4-4698-A74E-9A251D2A9355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  <a:endParaRPr lang="vi-V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ko-KR" altLang="en-US" noProof="0"/>
              <a:t>그림을 추가하려면 아이콘을 클릭하십시오</a:t>
            </a:r>
            <a:endParaRPr lang="vi-VN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31DE9EC-D341-467D-A37D-F579B455FE58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E6946282-70B4-49EF-9014-DCBDC00AD1E0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제목 스타일 편집</a:t>
            </a:r>
            <a:endParaRPr lang="vi-VN" altLang="fr-FR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vi-VN" altLang="fr-FR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9B3AF6E1-342C-4CA0-94FB-BE06805466BB}" type="datetimeFigureOut">
              <a:rPr lang="vi-VN"/>
              <a:pPr>
                <a:defRPr/>
              </a:pPr>
              <a:t>07/03/2020</a:t>
            </a:fld>
            <a:endParaRPr lang="vi-V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vi-V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Arial" charset="0"/>
              </a:defRPr>
            </a:lvl1pPr>
          </a:lstStyle>
          <a:p>
            <a:fld id="{19BBFF9C-B948-4F3B-B72B-E4282A166359}" type="slidenum">
              <a:rPr lang="vi-VN" altLang="fr-FR"/>
              <a:pPr/>
              <a:t>‹#›</a:t>
            </a:fld>
            <a:endParaRPr lang="vi-VN" alt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1" fontAlgn="base" latinLnBrk="1" hangingPunct="1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2pPr>
      <a:lvl3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3pPr>
      <a:lvl4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4pPr>
      <a:lvl5pPr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5pPr>
      <a:lvl6pPr marL="4572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6pPr>
      <a:lvl7pPr marL="9144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7pPr>
      <a:lvl8pPr marL="13716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8pPr>
      <a:lvl9pPr marL="1828800" algn="ctr" rtl="0" eaLnBrk="1" fontAlgn="base" latinLnBrk="1" hangingPunct="1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</a:defRPr>
      </a:lvl9pPr>
    </p:titleStyle>
    <p:bodyStyle>
      <a:lvl1pPr marL="342900" indent="-3429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latinLnBrk="1" hangingPunct="1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vi-VN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그룹 4">
            <a:extLst>
              <a:ext uri="{FF2B5EF4-FFF2-40B4-BE49-F238E27FC236}">
                <a16:creationId xmlns:a16="http://schemas.microsoft.com/office/drawing/2014/main" id="{AC002735-8B9C-4109-907B-25B583800DEA}"/>
              </a:ext>
            </a:extLst>
          </p:cNvPr>
          <p:cNvGrpSpPr/>
          <p:nvPr/>
        </p:nvGrpSpPr>
        <p:grpSpPr>
          <a:xfrm>
            <a:off x="372037" y="0"/>
            <a:ext cx="8399925" cy="5871084"/>
            <a:chOff x="491152" y="21424"/>
            <a:chExt cx="8399925" cy="5871084"/>
          </a:xfrm>
        </p:grpSpPr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EF32E146-6861-4CAC-AEA9-7104DEBA3EC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20608" t="16992" r="36836" b="4723"/>
            <a:stretch/>
          </p:blipFill>
          <p:spPr>
            <a:xfrm>
              <a:off x="617273" y="203032"/>
              <a:ext cx="2721410" cy="2711769"/>
            </a:xfrm>
            <a:prstGeom prst="rect">
              <a:avLst/>
            </a:prstGeom>
          </p:spPr>
        </p:pic>
        <p:pic>
          <p:nvPicPr>
            <p:cNvPr id="3" name="그림 2">
              <a:extLst>
                <a:ext uri="{FF2B5EF4-FFF2-40B4-BE49-F238E27FC236}">
                  <a16:creationId xmlns:a16="http://schemas.microsoft.com/office/drawing/2014/main" id="{D5A8962F-C91C-4C1F-BC26-F4A6144C1C6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0608" t="16992" r="36582" b="4723"/>
            <a:stretch/>
          </p:blipFill>
          <p:spPr>
            <a:xfrm>
              <a:off x="3340950" y="203031"/>
              <a:ext cx="2737600" cy="2711769"/>
            </a:xfrm>
            <a:prstGeom prst="rect">
              <a:avLst/>
            </a:prstGeom>
          </p:spPr>
        </p:pic>
        <p:pic>
          <p:nvPicPr>
            <p:cNvPr id="4" name="그림 3">
              <a:extLst>
                <a:ext uri="{FF2B5EF4-FFF2-40B4-BE49-F238E27FC236}">
                  <a16:creationId xmlns:a16="http://schemas.microsoft.com/office/drawing/2014/main" id="{BE5469BF-3969-400E-BC9C-6AE2A0C51C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0608" t="17225" r="36962" b="4956"/>
            <a:stretch/>
          </p:blipFill>
          <p:spPr>
            <a:xfrm>
              <a:off x="6153477" y="245679"/>
              <a:ext cx="2737600" cy="2719705"/>
            </a:xfrm>
            <a:prstGeom prst="rect">
              <a:avLst/>
            </a:prstGeom>
          </p:spPr>
        </p:pic>
        <p:pic>
          <p:nvPicPr>
            <p:cNvPr id="20" name="그림 19">
              <a:extLst>
                <a:ext uri="{FF2B5EF4-FFF2-40B4-BE49-F238E27FC236}">
                  <a16:creationId xmlns:a16="http://schemas.microsoft.com/office/drawing/2014/main" id="{49C9B9FB-0209-408D-9EAB-E52CE6C2F2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20608" t="16524" r="36962" b="4956"/>
            <a:stretch/>
          </p:blipFill>
          <p:spPr>
            <a:xfrm>
              <a:off x="1947330" y="3163747"/>
              <a:ext cx="2721410" cy="2727979"/>
            </a:xfrm>
            <a:prstGeom prst="rect">
              <a:avLst/>
            </a:prstGeom>
          </p:spPr>
        </p:pic>
        <p:pic>
          <p:nvPicPr>
            <p:cNvPr id="21" name="그림 20">
              <a:extLst>
                <a:ext uri="{FF2B5EF4-FFF2-40B4-BE49-F238E27FC236}">
                  <a16:creationId xmlns:a16="http://schemas.microsoft.com/office/drawing/2014/main" id="{86F1CF9A-ACD1-4533-AF8A-B2B6D69F3A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20608" t="16992" r="36582" b="4067"/>
            <a:stretch/>
          </p:blipFill>
          <p:spPr>
            <a:xfrm>
              <a:off x="4817414" y="3158035"/>
              <a:ext cx="2737600" cy="2734473"/>
            </a:xfrm>
            <a:prstGeom prst="rect">
              <a:avLst/>
            </a:prstGeom>
          </p:spPr>
        </p:pic>
        <p:grpSp>
          <p:nvGrpSpPr>
            <p:cNvPr id="19" name="그룹 18">
              <a:extLst>
                <a:ext uri="{FF2B5EF4-FFF2-40B4-BE49-F238E27FC236}">
                  <a16:creationId xmlns:a16="http://schemas.microsoft.com/office/drawing/2014/main" id="{F71FB121-B777-4FE0-A603-6F573B547DA7}"/>
                </a:ext>
              </a:extLst>
            </p:cNvPr>
            <p:cNvGrpSpPr/>
            <p:nvPr/>
          </p:nvGrpSpPr>
          <p:grpSpPr>
            <a:xfrm>
              <a:off x="491152" y="21424"/>
              <a:ext cx="6012778" cy="3462123"/>
              <a:chOff x="491152" y="21424"/>
              <a:chExt cx="6012778" cy="3462123"/>
            </a:xfrm>
          </p:grpSpPr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76A584A5-C154-4500-A259-3464DCF72E7B}"/>
                  </a:ext>
                </a:extLst>
              </p:cNvPr>
              <p:cNvSpPr txBox="1"/>
              <p:nvPr/>
            </p:nvSpPr>
            <p:spPr>
              <a:xfrm>
                <a:off x="491152" y="21424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A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61F10E17-81CD-49A2-8FAB-4DA98CF2C4EC}"/>
                  </a:ext>
                </a:extLst>
              </p:cNvPr>
              <p:cNvSpPr txBox="1"/>
              <p:nvPr/>
            </p:nvSpPr>
            <p:spPr>
              <a:xfrm>
                <a:off x="3338683" y="21424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B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E56DCA6-2389-43F9-B69B-314264FCDAC6}"/>
                  </a:ext>
                </a:extLst>
              </p:cNvPr>
              <p:cNvSpPr txBox="1"/>
              <p:nvPr/>
            </p:nvSpPr>
            <p:spPr>
              <a:xfrm>
                <a:off x="6186214" y="21424"/>
                <a:ext cx="31771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C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726EE99-E8D2-4A23-B396-E82DED0F6092}"/>
                  </a:ext>
                </a:extLst>
              </p:cNvPr>
              <p:cNvSpPr txBox="1"/>
              <p:nvPr/>
            </p:nvSpPr>
            <p:spPr>
              <a:xfrm>
                <a:off x="2024846" y="3114215"/>
                <a:ext cx="327334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D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5224795B-50C1-4FAC-A5B8-E84CD278DA2D}"/>
                  </a:ext>
                </a:extLst>
              </p:cNvPr>
              <p:cNvSpPr txBox="1"/>
              <p:nvPr/>
            </p:nvSpPr>
            <p:spPr>
              <a:xfrm>
                <a:off x="4924215" y="3113967"/>
                <a:ext cx="296876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E</a:t>
                </a:r>
              </a:p>
            </p:txBody>
          </p:sp>
        </p:grp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2BD42F44-96F2-4F4B-A686-701B8BD7405A}"/>
              </a:ext>
            </a:extLst>
          </p:cNvPr>
          <p:cNvSpPr txBox="1"/>
          <p:nvPr/>
        </p:nvSpPr>
        <p:spPr>
          <a:xfrm>
            <a:off x="96740" y="5928667"/>
            <a:ext cx="895052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. The UPGMA </a:t>
            </a:r>
            <a:r>
              <a:rPr lang="en-US" altLang="ko-KR" sz="16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ndrograms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the 223 cultivated pumpkin accessions using the 192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, 96 (B), 48 (C), 24 (D), and 12 (E) </a:t>
            </a:r>
            <a:r>
              <a:rPr lang="en-US" altLang="ko-KR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rkers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color codes indicate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axima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blue)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chata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red)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axima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x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. </a:t>
            </a:r>
            <a:r>
              <a:rPr lang="en-US" altLang="ko-KR" sz="16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oschata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ybrid (orange), </a:t>
            </a:r>
            <a:r>
              <a:rPr lang="en-US" altLang="ko-KR" sz="16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pepo </a:t>
            </a:r>
            <a:r>
              <a:rPr lang="en-US" altLang="ko-KR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green), and unknown (gray</a:t>
            </a:r>
            <a:r>
              <a:rPr lang="en-US" altLang="ko-KR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ko-KR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essions</a:t>
            </a:r>
            <a:r>
              <a:rPr lang="en-US" altLang="ko-KR" sz="160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ko-KR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9385204"/>
      </p:ext>
    </p:extLst>
  </p:cSld>
  <p:clrMapOvr>
    <a:masterClrMapping/>
  </p:clrMapOvr>
</p:sld>
</file>

<file path=ppt/theme/theme1.xml><?xml version="1.0" encoding="utf-8"?>
<a:theme xmlns:a="http://schemas.openxmlformats.org/drawingml/2006/main" name="theme 1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 1" id="{EDB62F8C-0C32-44F6-998E-439F59C6F9FB}" vid="{46AF7F10-F817-4C45-80B1-D634AB534084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20</TotalTime>
  <Words>82</Words>
  <Application>Microsoft Office PowerPoint</Application>
  <PresentationFormat>화면 슬라이드 쇼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Times New Roman</vt:lpstr>
      <vt:lpstr>theme 1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민경</dc:creator>
  <cp:lastModifiedBy>user1018</cp:lastModifiedBy>
  <cp:revision>8</cp:revision>
  <dcterms:created xsi:type="dcterms:W3CDTF">2020-03-06T10:28:00Z</dcterms:created>
  <dcterms:modified xsi:type="dcterms:W3CDTF">2020-03-07T10:38:13Z</dcterms:modified>
</cp:coreProperties>
</file>